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 horzBarState="maximized">
    <p:restoredLeft sz="15620"/>
    <p:restoredTop sz="93834" autoAdjust="0"/>
  </p:normalViewPr>
  <p:slideViewPr>
    <p:cSldViewPr>
      <p:cViewPr>
        <p:scale>
          <a:sx n="70" d="100"/>
          <a:sy n="70" d="100"/>
        </p:scale>
        <p:origin x="1564" y="3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2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Evaluation of balloon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lmonary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gioplasty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ing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l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ng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erfusion SPECT in patients with chronic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romboembolic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lmonary </a:t>
            </a:r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</a:t>
            </a:r>
            <a:r>
              <a:rPr lang="en-US" altLang="ja-JP" sz="2000" b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ypertension</a:t>
            </a:r>
            <a:endParaRPr lang="en-US" altLang="en-US" sz="66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400061" indent="-400061" algn="just">
              <a:lnSpc>
                <a:spcPct val="100000"/>
              </a:lnSpc>
              <a:spcBef>
                <a:spcPts val="0"/>
              </a:spcBef>
              <a:spcAft>
                <a:spcPts val="467"/>
              </a:spcAft>
              <a:buAutoNum type="arabicPeriod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epartment of Cardiovascular Medicine, Toho University Faculty of Medicine, Tokyo, Japan</a:t>
            </a:r>
          </a:p>
          <a:p>
            <a:pPr marL="400061" indent="-400061" algn="just">
              <a:lnSpc>
                <a:spcPct val="100000"/>
              </a:lnSpc>
              <a:spcBef>
                <a:spcPts val="0"/>
              </a:spcBef>
              <a:spcAft>
                <a:spcPts val="467"/>
              </a:spcAft>
              <a:buAutoNum type="arabicPeriod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epartment of Radiology, Toho University Faculty of Medicine, Tokyo, Japan</a:t>
            </a:r>
          </a:p>
          <a:p>
            <a:pPr algn="just">
              <a:lnSpc>
                <a:spcPct val="120000"/>
              </a:lnSpc>
            </a:pP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idenobu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Hashimoto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akashi Oka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ine Nakanishi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una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izumura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hintar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obashi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Yukiko Hashimoto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Yukiko Hashimoto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Yuriko Okamura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Kyoko Ota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Takanori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keda,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lvl="1"/>
            <a:endParaRPr lang="en-US" altLang="en-US" sz="2400" dirty="0"/>
          </a:p>
          <a:p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65E46AD2-987E-4EF2-A52D-DBCE1740B63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86" t="1501" r="11650" b="-1501"/>
          <a:stretch/>
        </p:blipFill>
        <p:spPr>
          <a:xfrm rot="5340000">
            <a:off x="1490422" y="3958174"/>
            <a:ext cx="1448910" cy="139304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E16AB099-A1FC-4A56-919F-F404852454A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0717" y="3959153"/>
            <a:ext cx="1337365" cy="136510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hronic thromboembolic pulmonary hypertension (CTEPH) develops in approximately 3.8% of patients surviving the acute phase of pulmonary embolism.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tients with a severe grade of CTEPH have a poor prognosis. </a:t>
            </a:r>
            <a:r>
              <a:rPr lang="en-US" altLang="ja-JP" sz="1800" kern="0" dirty="0"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And m</a:t>
            </a:r>
            <a:r>
              <a:rPr lang="en-US" altLang="ja-JP" sz="1800" kern="0" dirty="0">
                <a:effectLst/>
                <a:ea typeface="游明朝" panose="02020400000000000000" pitchFamily="18" charset="-128"/>
              </a:rPr>
              <a:t>ore than a third of patients with CTEPH are considered inoperable.</a:t>
            </a:r>
            <a:endParaRPr lang="en-US" altLang="en-US" sz="2800" dirty="0"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3-</a:t>
            </a:r>
            <a:r>
              <a:rPr lang="en-US" altLang="ja-JP" sz="1800" kern="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B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lloon pulmonary angioplasty (BPA) improves the prognosis of the patients with inoperable CTEPH.</a:t>
            </a:r>
            <a:endParaRPr lang="en-US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US" altLang="en-US" sz="1800" dirty="0"/>
              <a:t>T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 quantitative measurement of treatment effectiveness in patients with CTEPH using imaging modalities has not been well established.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5- </a:t>
            </a:r>
            <a:r>
              <a:rPr lang="en-US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 aimed to investigate the effectiveness of BPA in patients with CTEPH using lung perfusion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ingle-photon emission computed tomography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SPECT).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1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</a:t>
            </a:r>
            <a:r>
              <a:rPr kumimoji="1" lang="en-US" altLang="ja-JP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Twenty consecutive patients (64±15y) who were diagnosed  with CTEPH between January 2017 and January 2021 wer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e include in this study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kumimoji="1" lang="en-US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ll participants underwent lung perfusion SPECT before and after BPA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Chest CT underwent within 30 days before BPA was used for chest anatomical data. 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unctional chest volume and anatomical chest volume were calculated using software from lung perfusion SPECT data and chest CT data.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5-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unctional %volume of lung calculated from lung perfusion SPECT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and chest CT (FVL-LPSPECT)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(%) = Functional lung volume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calculated from lung perfusion SPECT (cm3) / Lung volume calculated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chest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cm3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endParaRPr lang="en-US" altLang="ja-JP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kumimoji="1" lang="ja-JP" altLang="en-US" sz="18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000" dirty="0"/>
              <a:t>                     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2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1-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The relationships between functional volume ratio calculated from imaging data and various clinical parameters before and after BPA were assessed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2- 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ultiple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 regression analysis was used to determine predictors for mean pulmonary artery pressure as treatment effectiveness.</a:t>
            </a:r>
            <a:endParaRPr lang="en-US" altLang="en-US" sz="2800" dirty="0"/>
          </a:p>
          <a:p>
            <a:pPr marL="0" indent="0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en-US" altLang="en-US" sz="2000" dirty="0">
                <a:solidFill>
                  <a:srgbClr val="000000"/>
                </a:solidFill>
              </a:rPr>
              <a:t>                    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C328B6D5-9F65-4C1A-9DFC-E94579B543B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56"/>
          <a:stretch/>
        </p:blipFill>
        <p:spPr>
          <a:xfrm>
            <a:off x="1671503" y="3595290"/>
            <a:ext cx="2484757" cy="2279613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019ABE2-DEF7-42DB-9953-6C00450AF381}"/>
              </a:ext>
            </a:extLst>
          </p:cNvPr>
          <p:cNvSpPr txBox="1"/>
          <p:nvPr/>
        </p:nvSpPr>
        <p:spPr>
          <a:xfrm>
            <a:off x="2438400" y="3615023"/>
            <a:ext cx="1289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fore BPA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84AFADBA-F019-4396-9246-29E76B189E4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371"/>
          <a:stretch/>
        </p:blipFill>
        <p:spPr>
          <a:xfrm>
            <a:off x="4841275" y="3615023"/>
            <a:ext cx="2497057" cy="2263048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A91CB94-236F-45B6-B82D-2A3AC00BE70B}"/>
              </a:ext>
            </a:extLst>
          </p:cNvPr>
          <p:cNvSpPr txBox="1"/>
          <p:nvPr/>
        </p:nvSpPr>
        <p:spPr>
          <a:xfrm>
            <a:off x="5659208" y="3615023"/>
            <a:ext cx="1600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fter BPA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D8F2A09-0CD6-4454-A821-AD0B37E5AFCD}"/>
              </a:ext>
            </a:extLst>
          </p:cNvPr>
          <p:cNvSpPr txBox="1"/>
          <p:nvPr/>
        </p:nvSpPr>
        <p:spPr>
          <a:xfrm>
            <a:off x="1447800" y="3283210"/>
            <a:ext cx="6400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ECT and CT fusion images of a patient with CTEPH before and after BP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3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6" name="コンテンツ プレースホルダー 5">
            <a:extLst>
              <a:ext uri="{FF2B5EF4-FFF2-40B4-BE49-F238E27FC236}">
                <a16:creationId xmlns:a16="http://schemas.microsoft.com/office/drawing/2014/main" id="{B079DB88-CD77-46A1-A718-31C1C133084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228600" y="2286000"/>
            <a:ext cx="3978040" cy="3093532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8415AC2-D862-44EF-BF0B-296DF2427A5E}"/>
              </a:ext>
            </a:extLst>
          </p:cNvPr>
          <p:cNvSpPr txBox="1"/>
          <p:nvPr/>
        </p:nvSpPr>
        <p:spPr>
          <a:xfrm>
            <a:off x="0" y="1770013"/>
            <a:ext cx="49347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1. </a:t>
            </a:r>
          </a:p>
          <a:p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linical parameters and LPSPECT parameters before and after BPA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FEAD454-92BF-4A23-B914-AA10B5A1EED3}"/>
              </a:ext>
            </a:extLst>
          </p:cNvPr>
          <p:cNvSpPr txBox="1"/>
          <p:nvPr/>
        </p:nvSpPr>
        <p:spPr>
          <a:xfrm>
            <a:off x="4584588" y="1770013"/>
            <a:ext cx="464820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2.</a:t>
            </a:r>
          </a:p>
          <a:p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earman’s correlation and </a:t>
            </a:r>
            <a:r>
              <a:rPr lang="en-US" altLang="ja-JP" sz="105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ultiple regression analyses for a dependent variable in </a:t>
            </a:r>
            <a:r>
              <a:rPr lang="en-US" altLang="ja-JP" sz="1050" kern="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PAP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67C51C8A-D9F1-4FFC-8E8D-FD554F5D8E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9413" y="2202076"/>
            <a:ext cx="4648200" cy="21383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is study demonstrated that the lung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erfusion SPECT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uld be a potential measurement of the effectiveness of BPA in patients with CTEPH.</a:t>
            </a:r>
            <a:endParaRPr lang="en-US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altLang="en-US" sz="1800" dirty="0"/>
              <a:t>BPA is the only treatment that can reach complete recovery for patients with 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operable CTEPH. </a:t>
            </a:r>
            <a:r>
              <a:rPr lang="en-US" altLang="ja-JP" sz="1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novative</a:t>
            </a:r>
            <a:r>
              <a:rPr lang="en-US" altLang="ja-JP" sz="18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use of imaging modalities, BPA </a:t>
            </a:r>
            <a:r>
              <a:rPr lang="en-US" altLang="en-US" sz="1800" dirty="0"/>
              <a:t>could be performed more safely and more effectively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9</TotalTime>
  <Words>592</Words>
  <Application>Microsoft Office PowerPoint</Application>
  <PresentationFormat>画面に合わせる (4:3)</PresentationFormat>
  <Paragraphs>52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SsykbnAdvPTimes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Evaluation of balloon pulmonary angioplasty using lung perfusion SPECT in patients with chronic thromboembolic pulmonary hypertension</vt:lpstr>
      <vt:lpstr>BACKGROUND</vt:lpstr>
      <vt:lpstr>Summary- 1</vt:lpstr>
      <vt:lpstr>Summary- 2</vt:lpstr>
      <vt:lpstr>Summary- 3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橋本 英伸</cp:lastModifiedBy>
  <cp:revision>109</cp:revision>
  <dcterms:created xsi:type="dcterms:W3CDTF">2011-04-18T21:44:13Z</dcterms:created>
  <dcterms:modified xsi:type="dcterms:W3CDTF">2022-03-20T22:13:12Z</dcterms:modified>
</cp:coreProperties>
</file>